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5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32369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565190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6085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5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Beran</a:t>
            </a:r>
            <a:r>
              <a:rPr lang="en-GB" dirty="0"/>
              <a:t> et al (2021) Diabetologia DOI 10.1007/s00125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020-05375-2</a:t>
            </a:r>
            <a:r>
              <a:rPr lang="en-GB" dirty="0"/>
              <a:t>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hematic of WHO framework on understanding the life cycle of medicines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9742FEE-F108-456D-A405-599153467E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59832" y="836712"/>
            <a:ext cx="3024336" cy="49650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era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1) Diabetologia DOI 10.1007/s00125-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020-05375-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1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sts of production and government procurement, and public and private sector patient prices for human and analogue insulin, based on 43 countri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53607B-95AA-490B-ABE3-C48A7EED13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1864" y="1055148"/>
            <a:ext cx="7236296" cy="47477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37222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era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1) Diabetologia DOI 10.1007/s00125-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020-05375-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1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vailability of insulin in the public and private sectors in a variety of countries in sub-Saharan Afric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A597C2B-17EA-484C-8FF1-C9923156A7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10176" y="1771998"/>
            <a:ext cx="6539672" cy="3589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4821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era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1) Diabetologia DOI 10.1007/s00125-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020-05375-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1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9512" y="260648"/>
            <a:ext cx="88204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mmary of barriers and solutions to overcome these to improve access to insul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766572E-94AC-4DCC-9828-19D012619A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56128" y="660758"/>
            <a:ext cx="4431743" cy="5205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5677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229</Words>
  <Application>Microsoft Office PowerPoint</Application>
  <PresentationFormat>On-screen Show (4:3)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37</cp:revision>
  <dcterms:created xsi:type="dcterms:W3CDTF">2016-06-15T12:53:43Z</dcterms:created>
  <dcterms:modified xsi:type="dcterms:W3CDTF">2021-01-15T13:39:24Z</dcterms:modified>
</cp:coreProperties>
</file>